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3" autoAdjust="0"/>
    <p:restoredTop sz="94660"/>
  </p:normalViewPr>
  <p:slideViewPr>
    <p:cSldViewPr snapToGrid="0">
      <p:cViewPr varScale="1">
        <p:scale>
          <a:sx n="93" d="100"/>
          <a:sy n="93" d="100"/>
        </p:scale>
        <p:origin x="51" y="2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265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40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642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182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041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805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03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829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126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3715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269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BE2103-AFBA-4D62-B8AD-51A8C0C65A32}" type="datetimeFigureOut">
              <a:rPr lang="en-US" smtClean="0"/>
              <a:t>1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DA9C62-093B-4508-81CE-EE1C158BA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018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017870" y="554982"/>
            <a:ext cx="5650173" cy="4331090"/>
            <a:chOff x="3345416" y="1118734"/>
            <a:chExt cx="5650173" cy="433109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98" r="1189"/>
            <a:stretch/>
          </p:blipFill>
          <p:spPr>
            <a:xfrm>
              <a:off x="3345416" y="1408176"/>
              <a:ext cx="5650173" cy="4041648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3386856" y="1118734"/>
              <a:ext cx="55885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M     1     2             3                 4       5     6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2967968" y="4944911"/>
            <a:ext cx="5795608" cy="14672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</a:pP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1.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riginal Figure 8A.</a:t>
            </a:r>
            <a:r>
              <a:rPr lang="en-US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I soluble expression and Purification. Coomassie stained 12% SDS-PAGE: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I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oluble expression in LB and OM-I media. M. Protein Marker. 1-3: POI soluble expression in LB media. 4-6: POI soluble expression in OM-I media. 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17920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751015" y="422164"/>
            <a:ext cx="6159546" cy="4343383"/>
            <a:chOff x="3028650" y="1266878"/>
            <a:chExt cx="6159546" cy="398503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64" t="-1" r="402" b="1337"/>
            <a:stretch/>
          </p:blipFill>
          <p:spPr>
            <a:xfrm flipH="1">
              <a:off x="3028650" y="1556004"/>
              <a:ext cx="6093725" cy="3695906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5910396" y="1266878"/>
              <a:ext cx="327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M           1            2   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Rectangle 6"/>
          <p:cNvSpPr/>
          <p:nvPr/>
        </p:nvSpPr>
        <p:spPr>
          <a:xfrm>
            <a:off x="2720364" y="4824386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Bef>
                <a:spcPts val="1200"/>
              </a:spcBef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2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riginal Figure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8B.</a:t>
            </a:r>
            <a:r>
              <a:rPr lang="en-US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I soluble expression and Purification. Coomassie stained 12% SDS-PAGE: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-INS POI IMAC purification. M. Protein Ladder.1: Cell lysate supernatant (Unpurified), 2: Purified POI.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65015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809165" y="565615"/>
            <a:ext cx="6583160" cy="4265388"/>
            <a:chOff x="3107436" y="1149384"/>
            <a:chExt cx="6583160" cy="4265388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3107436" y="1443228"/>
              <a:ext cx="5977128" cy="3971544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4102029" y="1149384"/>
              <a:ext cx="55885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M                                                            1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2749729" y="4772060"/>
            <a:ext cx="6096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Bef>
                <a:spcPts val="1200"/>
              </a:spcBef>
            </a:pP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3.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riginal Figure 9B.</a:t>
            </a: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-INS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I soluble expression in fermentor. Coomassie stained 12% SDS-PAGE: M. Protein Ladder.1: Post-induction cell lysate supernatants.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4912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36</Words>
  <Application>Microsoft Office PowerPoint</Application>
  <PresentationFormat>Widescreen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.bakhshi0098@gmail.com</dc:creator>
  <cp:lastModifiedBy>a.bakhshi0098@gmail.com</cp:lastModifiedBy>
  <cp:revision>5</cp:revision>
  <dcterms:created xsi:type="dcterms:W3CDTF">2021-11-23T15:34:38Z</dcterms:created>
  <dcterms:modified xsi:type="dcterms:W3CDTF">2021-11-27T20:15:58Z</dcterms:modified>
</cp:coreProperties>
</file>